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00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E:\专业学习\manuscript\Figs\submit-figs\FigS1.tif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78303" y="533400"/>
            <a:ext cx="5038725" cy="4552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762003" y="4890144"/>
            <a:ext cx="7467599" cy="1592744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Figure S2. TgPuf1 expression and subcellular localization in the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RH∆Ku80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parasit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Confirmation of the C-terminal HA x 3-tagging of the endogenous TgPuf1 locus. Two clones (C5 and C9) were probed with the anti-HA antibody. Lysate from wild-type RH strain parasite was included as a HA-negative contro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The lower, cross-reacting bands were probably degradation products of the tagged TgPuf1 protein, and they were detected in transfec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u∆Ku80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ines after longer exposure of the film.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) Expression of TgPuf1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achyzoite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radyzoite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he two stages of the parasite were differentiated by antibodies against BAG1, a protein expressed specifically in the bradyzoite stage. Anti-β-tubulin antibody served as a protein loading control. (C) Subcellular localization of TgPuf1 in tachyzoite and bradyzoite.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4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Toshib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iwangc</dc:creator>
  <cp:lastModifiedBy>微软用户</cp:lastModifiedBy>
  <cp:revision>7</cp:revision>
  <dcterms:created xsi:type="dcterms:W3CDTF">2014-02-05T04:36:47Z</dcterms:created>
  <dcterms:modified xsi:type="dcterms:W3CDTF">2014-03-21T15:07:50Z</dcterms:modified>
</cp:coreProperties>
</file>